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288588" cy="6858000"/>
  <p:notesSz cx="9867900" cy="67357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9867600" cy="6735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5590800" y="-360"/>
            <a:ext cx="4275000" cy="374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3024000" y="523440"/>
            <a:ext cx="3817800" cy="25448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559080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F1D287-60B6-459E-ADCB-7A2A4112CBED}" type="slidenum">
              <a:rPr b="1" lang="en-US" sz="1200" spc="-1" strike="noStrike">
                <a:solidFill>
                  <a:srgbClr val="000000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3024360" y="523800"/>
            <a:ext cx="3817800" cy="254484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1315800" y="3218040"/>
            <a:ext cx="7234200" cy="2993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スライド番号プレースホルダー 3"/>
          <p:cNvSpPr/>
          <p:nvPr/>
        </p:nvSpPr>
        <p:spPr>
          <a:xfrm>
            <a:off x="5591160" y="6361200"/>
            <a:ext cx="4275000" cy="37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5763A38-7F7C-404F-B732-D17C86DA54FD}" type="slidenum">
              <a:rPr b="1" lang="en-US" sz="1200" spc="-1" strike="noStrike">
                <a:solidFill>
                  <a:srgbClr val="ffffff"/>
                </a:solidFill>
                <a:latin typeface="Times New Roman"/>
                <a:ea typeface="中ゴシックＢＢＢ"/>
              </a:rPr>
              <a:t>&lt;number&gt;</a:t>
            </a:fld>
            <a:endParaRPr b="1" lang="en-US" sz="12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16D8E-9C91-4D2C-8261-7F7C83DADC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663557-6766-41B3-A5EB-D410B3C6952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77D81-580F-47CF-9810-E59AEF2989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72744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83760" y="198108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7112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72744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83760" y="4130640"/>
            <a:ext cx="28152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9ACCE-A2BC-48A0-A50C-0E0351872B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D121B-4114-40DB-AA45-156E206F4F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AA495-BD12-4AF4-8108-EA6FF9C33C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F4B899-DF28-4005-8908-8B294D4C879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422E01-445F-40FA-9562-8C604C82ADB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71120" y="609120"/>
            <a:ext cx="874404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885630-02CB-4AA4-B03F-2A40E3D991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7B9A1-B9FD-4DC6-83DE-B5A6063AB2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52040" y="413064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D3BBF-A411-40F6-AED3-48D3A567F5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7112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52040" y="1981080"/>
            <a:ext cx="426708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71120" y="4130640"/>
            <a:ext cx="874404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912CD-65AF-4D28-8D10-EA41FD1D4B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71120" y="609120"/>
            <a:ext cx="874404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ffff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ffff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71120" y="1981080"/>
            <a:ext cx="874404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ffffff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ffffff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7112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514320" y="6248520"/>
            <a:ext cx="32576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72080" y="6248520"/>
            <a:ext cx="214308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  <a:ea typeface="Osak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73AF6F-6A57-46A2-88C7-35F9CF32A8D4}" type="slidenum">
              <a:rPr b="0" lang="en-US" sz="1400" spc="-1" strike="noStrike">
                <a:solidFill>
                  <a:srgbClr val="ffffff"/>
                </a:solidFill>
                <a:latin typeface="Times New Roman"/>
                <a:ea typeface="Osaka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2"/>
          <p:cNvGrpSpPr/>
          <p:nvPr/>
        </p:nvGrpSpPr>
        <p:grpSpPr>
          <a:xfrm>
            <a:off x="-30240" y="752400"/>
            <a:ext cx="10329840" cy="4214520"/>
            <a:chOff x="-30240" y="752400"/>
            <a:chExt cx="10329840" cy="4214520"/>
          </a:xfrm>
        </p:grpSpPr>
        <p:sp>
          <p:nvSpPr>
            <p:cNvPr id="49" name="Text Box 27"/>
            <p:cNvSpPr/>
            <p:nvPr/>
          </p:nvSpPr>
          <p:spPr>
            <a:xfrm>
              <a:off x="3429000" y="752400"/>
              <a:ext cx="3261960" cy="825480"/>
            </a:xfrm>
            <a:prstGeom prst="rect">
              <a:avLst/>
            </a:prstGeom>
            <a:noFill/>
            <a:ln w="0">
              <a:noFill/>
            </a:ln>
            <a:effectLst>
              <a:outerShdw dist="17819" dir="2700000" blurRad="0" rotWithShape="0">
                <a:srgbClr val="00003d">
                  <a:alpha val="7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erioperative outcomes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0" name="Line 28"/>
            <p:cNvSpPr/>
            <p:nvPr/>
          </p:nvSpPr>
          <p:spPr>
            <a:xfrm>
              <a:off x="0" y="491184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1" name="Line 33"/>
            <p:cNvSpPr/>
            <p:nvPr/>
          </p:nvSpPr>
          <p:spPr>
            <a:xfrm>
              <a:off x="-30240" y="131580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2" name="Rectangle 55"/>
            <p:cNvSpPr/>
            <p:nvPr/>
          </p:nvSpPr>
          <p:spPr>
            <a:xfrm>
              <a:off x="36000" y="768240"/>
              <a:ext cx="146232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Table S2.</a:t>
              </a:r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3" name="Line 34"/>
            <p:cNvSpPr/>
            <p:nvPr/>
          </p:nvSpPr>
          <p:spPr>
            <a:xfrm>
              <a:off x="12600" y="2531880"/>
              <a:ext cx="10287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4" name="Text Box 25"/>
            <p:cNvSpPr/>
            <p:nvPr/>
          </p:nvSpPr>
          <p:spPr>
            <a:xfrm>
              <a:off x="120240" y="2738520"/>
              <a:ext cx="4438440" cy="2228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edian operation time, minutes (range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edian</a:t>
              </a:r>
              <a:r>
                <a:rPr b="0" lang="ja-JP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 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blood loss, ml (range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Median number of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hospitalization days </a:t>
              </a:r>
              <a:r>
                <a:rPr b="0" lang="ja-JP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（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range</a:t>
              </a:r>
              <a:r>
                <a:rPr b="0" lang="ja-JP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）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5" name="Line 40"/>
            <p:cNvSpPr/>
            <p:nvPr/>
          </p:nvSpPr>
          <p:spPr>
            <a:xfrm>
              <a:off x="4319640" y="1917720"/>
              <a:ext cx="4172040" cy="187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1" lang="en-US" sz="24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6" name="Rectangle 42"/>
            <p:cNvSpPr/>
            <p:nvPr/>
          </p:nvSpPr>
          <p:spPr>
            <a:xfrm>
              <a:off x="8833680" y="1741320"/>
              <a:ext cx="10555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p </a:t>
              </a: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Value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7" name="Text Box 43"/>
            <p:cNvSpPr/>
            <p:nvPr/>
          </p:nvSpPr>
          <p:spPr>
            <a:xfrm>
              <a:off x="8875800" y="2735280"/>
              <a:ext cx="860400" cy="192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027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450.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0.444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8" name="Rectangle 48"/>
            <p:cNvSpPr/>
            <p:nvPr/>
          </p:nvSpPr>
          <p:spPr>
            <a:xfrm>
              <a:off x="5290920" y="1434960"/>
              <a:ext cx="14000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Diversion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59" name="Rectangle 49"/>
            <p:cNvSpPr/>
            <p:nvPr/>
          </p:nvSpPr>
          <p:spPr>
            <a:xfrm>
              <a:off x="4658040" y="1996920"/>
              <a:ext cx="4291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IC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0" name="Rectangle 51"/>
            <p:cNvSpPr/>
            <p:nvPr/>
          </p:nvSpPr>
          <p:spPr>
            <a:xfrm>
              <a:off x="62280" y="1714320"/>
              <a:ext cx="11559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Variable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1" name="Text Box 56"/>
            <p:cNvSpPr/>
            <p:nvPr/>
          </p:nvSpPr>
          <p:spPr>
            <a:xfrm>
              <a:off x="4674960" y="2749680"/>
              <a:ext cx="2203200" cy="161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46 (315-706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500 (693-4203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7 (22-173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2" name="Rectangle 49"/>
            <p:cNvSpPr/>
            <p:nvPr/>
          </p:nvSpPr>
          <p:spPr>
            <a:xfrm>
              <a:off x="6713280" y="1996920"/>
              <a:ext cx="54036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NB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  <p:sp>
          <p:nvSpPr>
            <p:cNvPr id="63" name="Text Box 56"/>
            <p:cNvSpPr/>
            <p:nvPr/>
          </p:nvSpPr>
          <p:spPr>
            <a:xfrm>
              <a:off x="6737400" y="2749680"/>
              <a:ext cx="2101680" cy="1618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594 (381-714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1700 (560-4500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ＭＳ Ｐゴシック"/>
                  <a:ea typeface="ＭＳ Ｐゴシック"/>
                </a:rPr>
                <a:t>41 (17-99)</a:t>
              </a:r>
              <a:endParaRPr b="1" lang="en-US" sz="2000" spc="-1" strike="noStrike">
                <a:solidFill>
                  <a:srgbClr val="ffffff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0-05-10T06:54:23Z</dcterms:created>
  <dc:creator>pal</dc:creator>
  <dc:description/>
  <dc:language>en-US</dc:language>
  <cp:lastModifiedBy>NOZOMI HAYAKAWA</cp:lastModifiedBy>
  <cp:lastPrinted>2015-01-22T06:15:28Z</cp:lastPrinted>
  <dcterms:modified xsi:type="dcterms:W3CDTF">2015-08-05T00:20:07Z</dcterms:modified>
  <cp:revision>937</cp:revision>
  <dc:subject/>
  <dc:title>1501043</dc:title>
</cp:coreProperties>
</file>